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8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7E1E5-F12F-0A58-455D-206A6CA993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A4E1A8-C33B-9F33-70A0-91FCE69C2F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53298-1C9F-853E-1464-6FF592490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B8C1D5-A5CF-B1BB-EEDA-4FE1782B3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3B27A6-3A2F-DBC2-6DE0-84E20895B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31939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CF9B20-8300-0E4E-B7C6-E3D4607206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B4E2F2-EA70-E153-AC51-8210D31298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444957-F647-5792-99B1-CC0E0E683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0E35C2-5C47-4D63-DBF7-BCD05B440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8DA182-53A3-99AC-3799-9AB3CAE32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5810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B084E7-E745-D3B9-DE56-D6A22EB418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A146CF-2017-F4F9-6E4F-B84611CCC1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481DCB-AD45-2F4F-03E6-493F49921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F23C42-8B93-4577-CCB0-C5F68E595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0550E-5AF8-7EBE-D084-98979CD35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05637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CC312-1F2A-AC0F-6C6D-1B347211D4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FD908C-9E9C-4CC9-F132-A90672B0C0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6412B3-A1A1-8569-70DD-5B77762D1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8A80D-0C18-CABD-DAAE-F3EB63358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A32798-1EB9-2F96-0FE5-507AF4D55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71372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3FFB5E-59BA-7129-4E1C-982A831DC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3596CC-8E14-B252-433A-712EE2929B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1D753C-A2F2-543F-1FCA-B06DFD420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B4C947-0F00-A086-F04E-8F1F9590F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49B540-62EA-D538-029A-BF4C89550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86504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D7DCCA-14FD-BDE5-85EB-9123D39704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EF2878-A099-7FDF-2DAE-D69AF694AC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022002-8DB8-5C38-E9B8-E44BBCCEF4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429336-85D5-D71E-3E33-B54099945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BB82F6-F59A-6C3E-435F-176266489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6DFBC-A0A9-1A4A-EDDD-04EB235A9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3934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68B3D1-2917-E40A-84A7-638D14B3F9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9B2D13-1BC7-47D7-9046-0CB277528A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CDE46D-180A-EDE6-68DD-82DECE3EEA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33FA138-9D3F-42CC-E3AA-FE37546C91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8BDAF3-48E6-DD10-7D9F-006E83BE87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F9AE89-B1E0-00B8-61B8-AD3E0C4AD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BA5C5E-8B8A-FC5B-739C-56E67C1C86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43E67A-237D-2F4F-804D-5054ACD6F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550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F73B48-A0B4-237E-304B-E0315539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79ADDF-5542-97CA-3E82-B1725BB30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79D541-CC82-43EB-F2F0-F1BEC4A4D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AA8EF0-7027-53BF-AAB9-95A62DC8B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63700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045283-B450-6CD8-0B42-34B704F44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555449-FA70-CE6F-0FE9-48F2AC178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ED8390-DAD5-611A-7BED-38EA22494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34597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9929E-BAB2-8DB5-09F9-84A2C80CE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AC8EAD-5BB7-8FC6-74F3-5CEED2C245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7D3A6C-6F32-EC9D-4874-24CA54AC45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0ED6ED-8848-62B7-9EEE-8BD451B21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DF19C5-131C-695C-06CD-DE0BF65E4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2B5DE-68B9-2590-34DC-548CB3D55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39592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752804-9449-3A92-3FAB-E0824C218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C4AA124-B746-0DB9-7B46-59E46F1978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4EE995-1285-EFE0-F59B-9381C53000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275FD5-EC7D-C532-266A-7D69F5C98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C0BC0F-2DF1-0654-4C61-5606340AB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32055E-C601-67DB-6A8F-F81C4B466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544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50BE94-1B90-AB1F-A9E0-58BEC43D9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DC6D35-5C46-6FFC-1AA6-1BB2F33F45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54BCF2-E224-AE6B-B29D-6985004317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8C391B-43B8-4BE5-84BB-BDA16DCBC9F9}" type="datetimeFigureOut">
              <a:rPr lang="en-IN" smtClean="0"/>
              <a:t>01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01D83A-8730-5EFE-57E6-CA0B851CC2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8716AC-7DFA-02A7-9701-1D26D2D340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080DDA-1771-4875-B26A-59CB06DD89C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49992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9051D7-5B5B-E050-FF1F-F3CBBEFB9918}"/>
              </a:ext>
            </a:extLst>
          </p:cNvPr>
          <p:cNvSpPr txBox="1"/>
          <p:nvPr/>
        </p:nvSpPr>
        <p:spPr>
          <a:xfrm>
            <a:off x="704849" y="5546289"/>
            <a:ext cx="1102042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IN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6: 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romosomal distribution of lipid metabolic genes across the nine chromosomes. Each point represents a lipid-associated gene, </a:t>
            </a:r>
            <a:r>
              <a:rPr lang="en-IN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lored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y its enzyme functional class: Acyltransferases (red), Hydrolases such as lipases (green), Kinases (purple), Oxidoreductases such as desaturases (blue), </a:t>
            </a:r>
            <a:r>
              <a:rPr lang="en-IN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xygenases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orange), and Unclassified/Other (yellow). Chromosomes are arranged along the y-axis, scaled by their genomic length, with gene positions plotted along the x-axis based on genomic coordinates. </a:t>
            </a:r>
            <a:endParaRPr lang="en-IN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DA3117B-70EA-2CE4-8856-C9E3F964868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3963"/>
          <a:stretch>
            <a:fillRect/>
          </a:stretch>
        </p:blipFill>
        <p:spPr>
          <a:xfrm>
            <a:off x="1919287" y="480714"/>
            <a:ext cx="8353425" cy="48082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9700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ishor Tribhuvan</dc:creator>
  <cp:lastModifiedBy>Kishor Tribhuvan</cp:lastModifiedBy>
  <cp:revision>1</cp:revision>
  <dcterms:created xsi:type="dcterms:W3CDTF">2025-07-01T07:08:29Z</dcterms:created>
  <dcterms:modified xsi:type="dcterms:W3CDTF">2025-07-01T07:11:10Z</dcterms:modified>
</cp:coreProperties>
</file>